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81854" autoAdjust="0"/>
  </p:normalViewPr>
  <p:slideViewPr>
    <p:cSldViewPr snapToGrid="0" snapToObjects="1">
      <p:cViewPr>
        <p:scale>
          <a:sx n="89" d="100"/>
          <a:sy n="89" d="100"/>
        </p:scale>
        <p:origin x="-32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gierkes:Desktop:Figures:120413_U20S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5026210859889"/>
          <c:y val="3.0388773767620201E-2"/>
          <c:w val="0.89878357693794597"/>
          <c:h val="0.87787702492602404"/>
        </c:manualLayout>
      </c:layout>
      <c:scatterChart>
        <c:scatterStyle val="lineMarker"/>
        <c:varyColors val="0"/>
        <c:ser>
          <c:idx val="0"/>
          <c:order val="0"/>
          <c:tx>
            <c:v>Control</c:v>
          </c:tx>
          <c:spPr>
            <a:ln w="25400">
              <a:solidFill>
                <a:schemeClr val="accent2"/>
              </a:solidFill>
            </a:ln>
            <a:effectLst/>
          </c:spPr>
          <c:marker>
            <c:symbol val="circle"/>
            <c:size val="4"/>
            <c:spPr>
              <a:solidFill>
                <a:schemeClr val="accent2"/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20413_IncuCyteData_031014. (2)'!$H$10:$H$28</c:f>
                <c:numCache>
                  <c:formatCode>General</c:formatCode>
                  <c:ptCount val="19"/>
                  <c:pt idx="0">
                    <c:v>0.1666667</c:v>
                  </c:pt>
                  <c:pt idx="1">
                    <c:v>0</c:v>
                  </c:pt>
                  <c:pt idx="2">
                    <c:v>0.28867510000000002</c:v>
                  </c:pt>
                  <c:pt idx="3">
                    <c:v>0.76376259999999996</c:v>
                  </c:pt>
                  <c:pt idx="4">
                    <c:v>0.1666667</c:v>
                  </c:pt>
                  <c:pt idx="5">
                    <c:v>0</c:v>
                  </c:pt>
                  <c:pt idx="6">
                    <c:v>0.1666667</c:v>
                  </c:pt>
                  <c:pt idx="7">
                    <c:v>0</c:v>
                  </c:pt>
                  <c:pt idx="8">
                    <c:v>0.3333333</c:v>
                  </c:pt>
                  <c:pt idx="9">
                    <c:v>0.1666667</c:v>
                  </c:pt>
                  <c:pt idx="10">
                    <c:v>0.28867510000000002</c:v>
                  </c:pt>
                  <c:pt idx="11">
                    <c:v>0.88191710000000001</c:v>
                  </c:pt>
                  <c:pt idx="12">
                    <c:v>0.44095859999999998</c:v>
                  </c:pt>
                  <c:pt idx="13">
                    <c:v>0.28867510000000002</c:v>
                  </c:pt>
                  <c:pt idx="14">
                    <c:v>0.8333334</c:v>
                  </c:pt>
                  <c:pt idx="15">
                    <c:v>0.60092520000000005</c:v>
                  </c:pt>
                  <c:pt idx="16">
                    <c:v>0.57735029999999998</c:v>
                  </c:pt>
                  <c:pt idx="17">
                    <c:v>0.28867510000000002</c:v>
                  </c:pt>
                  <c:pt idx="18">
                    <c:v>0.7264832</c:v>
                  </c:pt>
                </c:numCache>
              </c:numRef>
            </c:plus>
            <c:minus>
              <c:numRef>
                <c:f>'120413_IncuCyteData_031014. (2)'!$H$10:$H$28</c:f>
                <c:numCache>
                  <c:formatCode>General</c:formatCode>
                  <c:ptCount val="19"/>
                  <c:pt idx="0">
                    <c:v>0.1666667</c:v>
                  </c:pt>
                  <c:pt idx="1">
                    <c:v>0</c:v>
                  </c:pt>
                  <c:pt idx="2">
                    <c:v>0.28867510000000002</c:v>
                  </c:pt>
                  <c:pt idx="3">
                    <c:v>0.76376259999999996</c:v>
                  </c:pt>
                  <c:pt idx="4">
                    <c:v>0.1666667</c:v>
                  </c:pt>
                  <c:pt idx="5">
                    <c:v>0</c:v>
                  </c:pt>
                  <c:pt idx="6">
                    <c:v>0.1666667</c:v>
                  </c:pt>
                  <c:pt idx="7">
                    <c:v>0</c:v>
                  </c:pt>
                  <c:pt idx="8">
                    <c:v>0.3333333</c:v>
                  </c:pt>
                  <c:pt idx="9">
                    <c:v>0.1666667</c:v>
                  </c:pt>
                  <c:pt idx="10">
                    <c:v>0.28867510000000002</c:v>
                  </c:pt>
                  <c:pt idx="11">
                    <c:v>0.88191710000000001</c:v>
                  </c:pt>
                  <c:pt idx="12">
                    <c:v>0.44095859999999998</c:v>
                  </c:pt>
                  <c:pt idx="13">
                    <c:v>0.28867510000000002</c:v>
                  </c:pt>
                  <c:pt idx="14">
                    <c:v>0.8333334</c:v>
                  </c:pt>
                  <c:pt idx="15">
                    <c:v>0.60092520000000005</c:v>
                  </c:pt>
                  <c:pt idx="16">
                    <c:v>0.57735029999999998</c:v>
                  </c:pt>
                  <c:pt idx="17">
                    <c:v>0.28867510000000002</c:v>
                  </c:pt>
                  <c:pt idx="18">
                    <c:v>0.7264832</c:v>
                  </c:pt>
                </c:numCache>
              </c:numRef>
            </c:minus>
          </c:errBars>
          <c:xVal>
            <c:numRef>
              <c:f>'120413_IncuCyteData_031014. (2)'!$B$10:$B$28</c:f>
              <c:numCache>
                <c:formatCode>General</c:formatCode>
                <c:ptCount val="1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</c:numCache>
            </c:numRef>
          </c:xVal>
          <c:yVal>
            <c:numRef>
              <c:f>'120413_IncuCyteData_031014. (2)'!$C$10:$C$28</c:f>
              <c:numCache>
                <c:formatCode>General</c:formatCode>
                <c:ptCount val="19"/>
                <c:pt idx="0">
                  <c:v>1.3333330000000001</c:v>
                </c:pt>
                <c:pt idx="1">
                  <c:v>1.5</c:v>
                </c:pt>
                <c:pt idx="2">
                  <c:v>1.5</c:v>
                </c:pt>
                <c:pt idx="3">
                  <c:v>2</c:v>
                </c:pt>
                <c:pt idx="4">
                  <c:v>1.8333330000000001</c:v>
                </c:pt>
                <c:pt idx="5">
                  <c:v>2</c:v>
                </c:pt>
                <c:pt idx="6">
                  <c:v>1.8333330000000001</c:v>
                </c:pt>
                <c:pt idx="7">
                  <c:v>1.5</c:v>
                </c:pt>
                <c:pt idx="8">
                  <c:v>1.8333330000000001</c:v>
                </c:pt>
                <c:pt idx="9">
                  <c:v>1.8333330000000001</c:v>
                </c:pt>
                <c:pt idx="10">
                  <c:v>2.5</c:v>
                </c:pt>
                <c:pt idx="11">
                  <c:v>3.3333330000000001</c:v>
                </c:pt>
                <c:pt idx="12">
                  <c:v>2.6666669999999981</c:v>
                </c:pt>
                <c:pt idx="13">
                  <c:v>3.5</c:v>
                </c:pt>
                <c:pt idx="14">
                  <c:v>4.3333329999999997</c:v>
                </c:pt>
                <c:pt idx="15">
                  <c:v>3.6666669999999981</c:v>
                </c:pt>
                <c:pt idx="16">
                  <c:v>4.5</c:v>
                </c:pt>
                <c:pt idx="17">
                  <c:v>4.5</c:v>
                </c:pt>
                <c:pt idx="18">
                  <c:v>5.1666670000000003</c:v>
                </c:pt>
              </c:numCache>
            </c:numRef>
          </c:yVal>
          <c:smooth val="0"/>
        </c:ser>
        <c:ser>
          <c:idx val="1"/>
          <c:order val="1"/>
          <c:tx>
            <c:v>DMSO</c:v>
          </c:tx>
          <c:spPr>
            <a:ln w="25400">
              <a:solidFill>
                <a:schemeClr val="accent6"/>
              </a:solidFill>
            </a:ln>
            <a:effectLst/>
          </c:spPr>
          <c:marker>
            <c:symbol val="circle"/>
            <c:size val="4"/>
            <c:spPr>
              <a:solidFill>
                <a:schemeClr val="accent6"/>
              </a:solidFill>
              <a:ln w="12700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20413_IncuCyteData_031014. (2)'!$I$10:$I$28</c:f>
                <c:numCache>
                  <c:formatCode>General</c:formatCode>
                  <c:ptCount val="19"/>
                  <c:pt idx="0">
                    <c:v>0.7264832</c:v>
                  </c:pt>
                  <c:pt idx="1">
                    <c:v>0.44095859999999998</c:v>
                  </c:pt>
                  <c:pt idx="2">
                    <c:v>0.3333333</c:v>
                  </c:pt>
                  <c:pt idx="3">
                    <c:v>0.3333333</c:v>
                  </c:pt>
                  <c:pt idx="4">
                    <c:v>0.28867510000000002</c:v>
                  </c:pt>
                  <c:pt idx="5">
                    <c:v>0.3333333</c:v>
                  </c:pt>
                  <c:pt idx="6">
                    <c:v>0.5</c:v>
                  </c:pt>
                  <c:pt idx="7">
                    <c:v>0.76376259999999996</c:v>
                  </c:pt>
                  <c:pt idx="8">
                    <c:v>0.66666669999999995</c:v>
                  </c:pt>
                  <c:pt idx="9">
                    <c:v>1.0929059999999999</c:v>
                  </c:pt>
                  <c:pt idx="10">
                    <c:v>1.0408329999999999</c:v>
                  </c:pt>
                  <c:pt idx="11">
                    <c:v>0.44095859999999998</c:v>
                  </c:pt>
                  <c:pt idx="12">
                    <c:v>0.60092520000000005</c:v>
                  </c:pt>
                  <c:pt idx="13">
                    <c:v>0.7264832</c:v>
                  </c:pt>
                  <c:pt idx="14">
                    <c:v>1.2583059999999999</c:v>
                  </c:pt>
                  <c:pt idx="15">
                    <c:v>1.2018500000000001</c:v>
                  </c:pt>
                  <c:pt idx="16">
                    <c:v>1.0929059999999999</c:v>
                  </c:pt>
                  <c:pt idx="17">
                    <c:v>1.1666669999999999</c:v>
                  </c:pt>
                  <c:pt idx="18">
                    <c:v>1.2018500000000001</c:v>
                  </c:pt>
                </c:numCache>
              </c:numRef>
            </c:plus>
            <c:minus>
              <c:numRef>
                <c:f>'120413_IncuCyteData_031014. (2)'!$I$10:$I$28</c:f>
                <c:numCache>
                  <c:formatCode>General</c:formatCode>
                  <c:ptCount val="19"/>
                  <c:pt idx="0">
                    <c:v>0.7264832</c:v>
                  </c:pt>
                  <c:pt idx="1">
                    <c:v>0.44095859999999998</c:v>
                  </c:pt>
                  <c:pt idx="2">
                    <c:v>0.3333333</c:v>
                  </c:pt>
                  <c:pt idx="3">
                    <c:v>0.3333333</c:v>
                  </c:pt>
                  <c:pt idx="4">
                    <c:v>0.28867510000000002</c:v>
                  </c:pt>
                  <c:pt idx="5">
                    <c:v>0.3333333</c:v>
                  </c:pt>
                  <c:pt idx="6">
                    <c:v>0.5</c:v>
                  </c:pt>
                  <c:pt idx="7">
                    <c:v>0.76376259999999996</c:v>
                  </c:pt>
                  <c:pt idx="8">
                    <c:v>0.66666669999999995</c:v>
                  </c:pt>
                  <c:pt idx="9">
                    <c:v>1.0929059999999999</c:v>
                  </c:pt>
                  <c:pt idx="10">
                    <c:v>1.0408329999999999</c:v>
                  </c:pt>
                  <c:pt idx="11">
                    <c:v>0.44095859999999998</c:v>
                  </c:pt>
                  <c:pt idx="12">
                    <c:v>0.60092520000000005</c:v>
                  </c:pt>
                  <c:pt idx="13">
                    <c:v>0.7264832</c:v>
                  </c:pt>
                  <c:pt idx="14">
                    <c:v>1.2583059999999999</c:v>
                  </c:pt>
                  <c:pt idx="15">
                    <c:v>1.2018500000000001</c:v>
                  </c:pt>
                  <c:pt idx="16">
                    <c:v>1.0929059999999999</c:v>
                  </c:pt>
                  <c:pt idx="17">
                    <c:v>1.1666669999999999</c:v>
                  </c:pt>
                  <c:pt idx="18">
                    <c:v>1.2018500000000001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  <a:effectLst/>
            </c:spPr>
          </c:errBars>
          <c:xVal>
            <c:numRef>
              <c:f>'120413_IncuCyteData_031014. (2)'!$B$10:$B$28</c:f>
              <c:numCache>
                <c:formatCode>General</c:formatCode>
                <c:ptCount val="1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</c:numCache>
            </c:numRef>
          </c:xVal>
          <c:yVal>
            <c:numRef>
              <c:f>'120413_IncuCyteData_031014. (2)'!$D$10:$D$28</c:f>
              <c:numCache>
                <c:formatCode>General</c:formatCode>
                <c:ptCount val="19"/>
                <c:pt idx="0">
                  <c:v>1.6666669999999999</c:v>
                </c:pt>
                <c:pt idx="1">
                  <c:v>1.6666669999999999</c:v>
                </c:pt>
                <c:pt idx="2">
                  <c:v>1.3333330000000001</c:v>
                </c:pt>
                <c:pt idx="3">
                  <c:v>1.6666669999999999</c:v>
                </c:pt>
                <c:pt idx="4">
                  <c:v>1.5</c:v>
                </c:pt>
                <c:pt idx="5">
                  <c:v>1.6666669999999999</c:v>
                </c:pt>
                <c:pt idx="6">
                  <c:v>1.5</c:v>
                </c:pt>
                <c:pt idx="7">
                  <c:v>2</c:v>
                </c:pt>
                <c:pt idx="8">
                  <c:v>2.166666999999999</c:v>
                </c:pt>
                <c:pt idx="9">
                  <c:v>2.3333330000000001</c:v>
                </c:pt>
                <c:pt idx="10">
                  <c:v>2.5</c:v>
                </c:pt>
                <c:pt idx="11">
                  <c:v>2.6666669999999981</c:v>
                </c:pt>
                <c:pt idx="12">
                  <c:v>4.1666670000000003</c:v>
                </c:pt>
                <c:pt idx="13">
                  <c:v>3.6666669999999981</c:v>
                </c:pt>
                <c:pt idx="14">
                  <c:v>4.5</c:v>
                </c:pt>
                <c:pt idx="15">
                  <c:v>4.6666670000000003</c:v>
                </c:pt>
                <c:pt idx="16">
                  <c:v>5.8333329999999997</c:v>
                </c:pt>
                <c:pt idx="17">
                  <c:v>6.1666670000000003</c:v>
                </c:pt>
                <c:pt idx="18">
                  <c:v>6.6666670000000003</c:v>
                </c:pt>
              </c:numCache>
            </c:numRef>
          </c:yVal>
          <c:smooth val="0"/>
        </c:ser>
        <c:ser>
          <c:idx val="2"/>
          <c:order val="2"/>
          <c:tx>
            <c:v>FRAX1036</c:v>
          </c:tx>
          <c:spPr>
            <a:ln w="25400"/>
            <a:effectLst/>
          </c:spPr>
          <c:marker>
            <c:symbol val="circle"/>
            <c:size val="4"/>
            <c:spPr>
              <a:solidFill>
                <a:schemeClr val="accent3"/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20413_IncuCyteData_031014. (2)'!$J$10:$J$28</c:f>
                <c:numCache>
                  <c:formatCode>General</c:formatCode>
                  <c:ptCount val="19"/>
                  <c:pt idx="0">
                    <c:v>0.60092520000000005</c:v>
                  </c:pt>
                  <c:pt idx="1">
                    <c:v>1.0137940000000001</c:v>
                  </c:pt>
                  <c:pt idx="2">
                    <c:v>1.922094</c:v>
                  </c:pt>
                  <c:pt idx="3">
                    <c:v>1.8782380000000001</c:v>
                  </c:pt>
                  <c:pt idx="4">
                    <c:v>2.2912880000000002</c:v>
                  </c:pt>
                  <c:pt idx="5">
                    <c:v>2.8431199999999999</c:v>
                  </c:pt>
                  <c:pt idx="6">
                    <c:v>2.2422710000000001</c:v>
                  </c:pt>
                  <c:pt idx="7">
                    <c:v>2.420973</c:v>
                  </c:pt>
                  <c:pt idx="8">
                    <c:v>1.3017080000000001</c:v>
                  </c:pt>
                  <c:pt idx="9">
                    <c:v>2.4037009999999999</c:v>
                  </c:pt>
                  <c:pt idx="10">
                    <c:v>2</c:v>
                  </c:pt>
                  <c:pt idx="11">
                    <c:v>2.4037009999999999</c:v>
                  </c:pt>
                  <c:pt idx="12">
                    <c:v>2.088327</c:v>
                  </c:pt>
                  <c:pt idx="13">
                    <c:v>2.4664410000000001</c:v>
                  </c:pt>
                  <c:pt idx="14">
                    <c:v>2.2422710000000001</c:v>
                  </c:pt>
                  <c:pt idx="15">
                    <c:v>1.2583059999999999</c:v>
                  </c:pt>
                  <c:pt idx="16">
                    <c:v>0.57735029999999998</c:v>
                  </c:pt>
                  <c:pt idx="17">
                    <c:v>1.8782380000000001</c:v>
                  </c:pt>
                  <c:pt idx="18">
                    <c:v>0.44095859999999998</c:v>
                  </c:pt>
                </c:numCache>
              </c:numRef>
            </c:plus>
            <c:minus>
              <c:numRef>
                <c:f>'120413_IncuCyteData_031014. (2)'!$J$10:$J$28</c:f>
                <c:numCache>
                  <c:formatCode>General</c:formatCode>
                  <c:ptCount val="19"/>
                  <c:pt idx="0">
                    <c:v>0.60092520000000005</c:v>
                  </c:pt>
                  <c:pt idx="1">
                    <c:v>1.0137940000000001</c:v>
                  </c:pt>
                  <c:pt idx="2">
                    <c:v>1.922094</c:v>
                  </c:pt>
                  <c:pt idx="3">
                    <c:v>1.8782380000000001</c:v>
                  </c:pt>
                  <c:pt idx="4">
                    <c:v>2.2912880000000002</c:v>
                  </c:pt>
                  <c:pt idx="5">
                    <c:v>2.8431199999999999</c:v>
                  </c:pt>
                  <c:pt idx="6">
                    <c:v>2.2422710000000001</c:v>
                  </c:pt>
                  <c:pt idx="7">
                    <c:v>2.420973</c:v>
                  </c:pt>
                  <c:pt idx="8">
                    <c:v>1.3017080000000001</c:v>
                  </c:pt>
                  <c:pt idx="9">
                    <c:v>2.4037009999999999</c:v>
                  </c:pt>
                  <c:pt idx="10">
                    <c:v>2</c:v>
                  </c:pt>
                  <c:pt idx="11">
                    <c:v>2.4037009999999999</c:v>
                  </c:pt>
                  <c:pt idx="12">
                    <c:v>2.088327</c:v>
                  </c:pt>
                  <c:pt idx="13">
                    <c:v>2.4664410000000001</c:v>
                  </c:pt>
                  <c:pt idx="14">
                    <c:v>2.2422710000000001</c:v>
                  </c:pt>
                  <c:pt idx="15">
                    <c:v>1.2583059999999999</c:v>
                  </c:pt>
                  <c:pt idx="16">
                    <c:v>0.57735029999999998</c:v>
                  </c:pt>
                  <c:pt idx="17">
                    <c:v>1.8782380000000001</c:v>
                  </c:pt>
                  <c:pt idx="18">
                    <c:v>0.44095859999999998</c:v>
                  </c:pt>
                </c:numCache>
              </c:numRef>
            </c:minus>
            <c:spPr>
              <a:ln w="12700"/>
              <a:effectLst/>
            </c:spPr>
          </c:errBars>
          <c:xVal>
            <c:numRef>
              <c:f>'120413_IncuCyteData_031014. (2)'!$B$10:$B$28</c:f>
              <c:numCache>
                <c:formatCode>General</c:formatCode>
                <c:ptCount val="1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</c:numCache>
            </c:numRef>
          </c:xVal>
          <c:yVal>
            <c:numRef>
              <c:f>'120413_IncuCyteData_031014. (2)'!$E$10:$E$28</c:f>
              <c:numCache>
                <c:formatCode>General</c:formatCode>
                <c:ptCount val="19"/>
                <c:pt idx="0">
                  <c:v>1.6666669999999999</c:v>
                </c:pt>
                <c:pt idx="1">
                  <c:v>3.8333330000000001</c:v>
                </c:pt>
                <c:pt idx="2">
                  <c:v>6.1666670000000003</c:v>
                </c:pt>
                <c:pt idx="3">
                  <c:v>8.1666670000000003</c:v>
                </c:pt>
                <c:pt idx="4">
                  <c:v>9.5</c:v>
                </c:pt>
                <c:pt idx="5">
                  <c:v>10.5</c:v>
                </c:pt>
                <c:pt idx="6">
                  <c:v>11.83333</c:v>
                </c:pt>
                <c:pt idx="7">
                  <c:v>15.33333</c:v>
                </c:pt>
                <c:pt idx="8">
                  <c:v>16.83333</c:v>
                </c:pt>
                <c:pt idx="9">
                  <c:v>21.66667</c:v>
                </c:pt>
                <c:pt idx="10">
                  <c:v>25</c:v>
                </c:pt>
                <c:pt idx="11">
                  <c:v>26.33333</c:v>
                </c:pt>
                <c:pt idx="12">
                  <c:v>29.33333</c:v>
                </c:pt>
                <c:pt idx="13">
                  <c:v>37</c:v>
                </c:pt>
                <c:pt idx="14">
                  <c:v>40.833329999999997</c:v>
                </c:pt>
                <c:pt idx="15">
                  <c:v>45</c:v>
                </c:pt>
                <c:pt idx="16">
                  <c:v>49.5</c:v>
                </c:pt>
                <c:pt idx="17">
                  <c:v>53.166670000000003</c:v>
                </c:pt>
                <c:pt idx="18">
                  <c:v>59.833329999999997</c:v>
                </c:pt>
              </c:numCache>
            </c:numRef>
          </c:yVal>
          <c:smooth val="0"/>
        </c:ser>
        <c:ser>
          <c:idx val="3"/>
          <c:order val="3"/>
          <c:tx>
            <c:v>DTX</c:v>
          </c:tx>
          <c:spPr>
            <a:ln w="25400"/>
            <a:effectLst/>
          </c:spPr>
          <c:marker>
            <c:symbol val="circle"/>
            <c:size val="4"/>
            <c:spPr>
              <a:solidFill>
                <a:schemeClr val="accent4"/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20413_IncuCyteData_031014. (2)'!$K$10:$K$28</c:f>
                <c:numCache>
                  <c:formatCode>General</c:formatCode>
                  <c:ptCount val="19"/>
                  <c:pt idx="0">
                    <c:v>0.57735029999999998</c:v>
                  </c:pt>
                  <c:pt idx="1">
                    <c:v>0.3333333</c:v>
                  </c:pt>
                  <c:pt idx="2">
                    <c:v>0.3333333</c:v>
                  </c:pt>
                  <c:pt idx="3">
                    <c:v>0.28867510000000002</c:v>
                  </c:pt>
                  <c:pt idx="4">
                    <c:v>0.5</c:v>
                  </c:pt>
                  <c:pt idx="5">
                    <c:v>0.44095859999999998</c:v>
                  </c:pt>
                  <c:pt idx="6">
                    <c:v>0.44095859999999998</c:v>
                  </c:pt>
                  <c:pt idx="7">
                    <c:v>0.44095859999999998</c:v>
                  </c:pt>
                  <c:pt idx="8">
                    <c:v>0.86602539999999995</c:v>
                  </c:pt>
                  <c:pt idx="9">
                    <c:v>1.2583059999999999</c:v>
                  </c:pt>
                  <c:pt idx="10">
                    <c:v>0.86602539999999995</c:v>
                  </c:pt>
                  <c:pt idx="11">
                    <c:v>2.315407</c:v>
                  </c:pt>
                  <c:pt idx="12">
                    <c:v>2.7436799999999999</c:v>
                  </c:pt>
                  <c:pt idx="13">
                    <c:v>2.088327</c:v>
                  </c:pt>
                  <c:pt idx="14">
                    <c:v>0.7264832</c:v>
                  </c:pt>
                  <c:pt idx="15">
                    <c:v>0.5</c:v>
                  </c:pt>
                  <c:pt idx="16">
                    <c:v>2.4551530000000001</c:v>
                  </c:pt>
                  <c:pt idx="17">
                    <c:v>0.92796080000000003</c:v>
                  </c:pt>
                  <c:pt idx="18">
                    <c:v>1.4240010000000001</c:v>
                  </c:pt>
                </c:numCache>
              </c:numRef>
            </c:plus>
            <c:minus>
              <c:numRef>
                <c:f>'120413_IncuCyteData_031014. (2)'!$K$10:$K$28</c:f>
                <c:numCache>
                  <c:formatCode>General</c:formatCode>
                  <c:ptCount val="19"/>
                  <c:pt idx="0">
                    <c:v>0.57735029999999998</c:v>
                  </c:pt>
                  <c:pt idx="1">
                    <c:v>0.3333333</c:v>
                  </c:pt>
                  <c:pt idx="2">
                    <c:v>0.3333333</c:v>
                  </c:pt>
                  <c:pt idx="3">
                    <c:v>0.28867510000000002</c:v>
                  </c:pt>
                  <c:pt idx="4">
                    <c:v>0.5</c:v>
                  </c:pt>
                  <c:pt idx="5">
                    <c:v>0.44095859999999998</c:v>
                  </c:pt>
                  <c:pt idx="6">
                    <c:v>0.44095859999999998</c:v>
                  </c:pt>
                  <c:pt idx="7">
                    <c:v>0.44095859999999998</c:v>
                  </c:pt>
                  <c:pt idx="8">
                    <c:v>0.86602539999999995</c:v>
                  </c:pt>
                  <c:pt idx="9">
                    <c:v>1.2583059999999999</c:v>
                  </c:pt>
                  <c:pt idx="10">
                    <c:v>0.86602539999999995</c:v>
                  </c:pt>
                  <c:pt idx="11">
                    <c:v>2.315407</c:v>
                  </c:pt>
                  <c:pt idx="12">
                    <c:v>2.7436799999999999</c:v>
                  </c:pt>
                  <c:pt idx="13">
                    <c:v>2.088327</c:v>
                  </c:pt>
                  <c:pt idx="14">
                    <c:v>0.7264832</c:v>
                  </c:pt>
                  <c:pt idx="15">
                    <c:v>0.5</c:v>
                  </c:pt>
                  <c:pt idx="16">
                    <c:v>2.4551530000000001</c:v>
                  </c:pt>
                  <c:pt idx="17">
                    <c:v>0.92796080000000003</c:v>
                  </c:pt>
                  <c:pt idx="18">
                    <c:v>1.4240010000000001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xVal>
            <c:numRef>
              <c:f>'120413_IncuCyteData_031014. (2)'!$B$10:$B$28</c:f>
              <c:numCache>
                <c:formatCode>General</c:formatCode>
                <c:ptCount val="1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</c:numCache>
            </c:numRef>
          </c:xVal>
          <c:yVal>
            <c:numRef>
              <c:f>'120413_IncuCyteData_031014. (2)'!$F$10:$F$28</c:f>
              <c:numCache>
                <c:formatCode>General</c:formatCode>
                <c:ptCount val="19"/>
                <c:pt idx="0">
                  <c:v>1.5</c:v>
                </c:pt>
                <c:pt idx="1">
                  <c:v>1.8333330000000001</c:v>
                </c:pt>
                <c:pt idx="2">
                  <c:v>1.8333330000000001</c:v>
                </c:pt>
                <c:pt idx="3">
                  <c:v>1.5</c:v>
                </c:pt>
                <c:pt idx="4">
                  <c:v>1.5</c:v>
                </c:pt>
                <c:pt idx="5">
                  <c:v>2.3333330000000001</c:v>
                </c:pt>
                <c:pt idx="6">
                  <c:v>3.3333330000000001</c:v>
                </c:pt>
                <c:pt idx="7">
                  <c:v>4.3333329999999997</c:v>
                </c:pt>
                <c:pt idx="8">
                  <c:v>7</c:v>
                </c:pt>
                <c:pt idx="9">
                  <c:v>9.5</c:v>
                </c:pt>
                <c:pt idx="10">
                  <c:v>11.5</c:v>
                </c:pt>
                <c:pt idx="11">
                  <c:v>19.16667</c:v>
                </c:pt>
                <c:pt idx="12">
                  <c:v>22.33333</c:v>
                </c:pt>
                <c:pt idx="13">
                  <c:v>29.83333</c:v>
                </c:pt>
                <c:pt idx="14">
                  <c:v>34.166670000000003</c:v>
                </c:pt>
                <c:pt idx="15">
                  <c:v>41.5</c:v>
                </c:pt>
                <c:pt idx="16">
                  <c:v>49.166670000000003</c:v>
                </c:pt>
                <c:pt idx="17">
                  <c:v>58.833329999999997</c:v>
                </c:pt>
                <c:pt idx="18">
                  <c:v>63.833329999999997</c:v>
                </c:pt>
              </c:numCache>
            </c:numRef>
          </c:yVal>
          <c:smooth val="0"/>
        </c:ser>
        <c:ser>
          <c:idx val="4"/>
          <c:order val="4"/>
          <c:tx>
            <c:v>FRAX1036 + DTX</c:v>
          </c:tx>
          <c:spPr>
            <a:ln w="25400"/>
            <a:effectLst/>
          </c:spPr>
          <c:marker>
            <c:symbol val="circle"/>
            <c:size val="4"/>
            <c:spPr>
              <a:solidFill>
                <a:schemeClr val="accent5"/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20413_IncuCyteData_031014. (2)'!$L$10:$L$28</c:f>
                <c:numCache>
                  <c:formatCode>General</c:formatCode>
                  <c:ptCount val="19"/>
                  <c:pt idx="0">
                    <c:v>0.28867510000000002</c:v>
                  </c:pt>
                  <c:pt idx="1">
                    <c:v>0.1666667</c:v>
                  </c:pt>
                  <c:pt idx="2">
                    <c:v>1.607275</c:v>
                  </c:pt>
                  <c:pt idx="3">
                    <c:v>2.204793</c:v>
                  </c:pt>
                  <c:pt idx="4">
                    <c:v>1.6914819999999999</c:v>
                  </c:pt>
                  <c:pt idx="5">
                    <c:v>1.7638339999999999</c:v>
                  </c:pt>
                  <c:pt idx="6">
                    <c:v>2.166666999999999</c:v>
                  </c:pt>
                  <c:pt idx="7">
                    <c:v>3.9405299999999999</c:v>
                  </c:pt>
                  <c:pt idx="8">
                    <c:v>5.7951129999999909</c:v>
                  </c:pt>
                  <c:pt idx="9">
                    <c:v>7.1550299999999956</c:v>
                  </c:pt>
                  <c:pt idx="10">
                    <c:v>9.9680050000000016</c:v>
                  </c:pt>
                  <c:pt idx="11">
                    <c:v>8.0829039999999992</c:v>
                  </c:pt>
                  <c:pt idx="12">
                    <c:v>9.3377970000000001</c:v>
                  </c:pt>
                  <c:pt idx="13">
                    <c:v>9.5175289999999997</c:v>
                  </c:pt>
                  <c:pt idx="14">
                    <c:v>10.29968</c:v>
                  </c:pt>
                  <c:pt idx="15">
                    <c:v>11.655950000000001</c:v>
                  </c:pt>
                  <c:pt idx="16">
                    <c:v>11.59023</c:v>
                  </c:pt>
                  <c:pt idx="17">
                    <c:v>9.0875380000000003</c:v>
                  </c:pt>
                  <c:pt idx="18">
                    <c:v>7.6974019999999657</c:v>
                  </c:pt>
                </c:numCache>
              </c:numRef>
            </c:plus>
            <c:minus>
              <c:numRef>
                <c:f>'120413_IncuCyteData_031014. (2)'!$L$10:$L$28</c:f>
                <c:numCache>
                  <c:formatCode>General</c:formatCode>
                  <c:ptCount val="19"/>
                  <c:pt idx="0">
                    <c:v>0.28867510000000002</c:v>
                  </c:pt>
                  <c:pt idx="1">
                    <c:v>0.1666667</c:v>
                  </c:pt>
                  <c:pt idx="2">
                    <c:v>1.607275</c:v>
                  </c:pt>
                  <c:pt idx="3">
                    <c:v>2.204793</c:v>
                  </c:pt>
                  <c:pt idx="4">
                    <c:v>1.6914819999999999</c:v>
                  </c:pt>
                  <c:pt idx="5">
                    <c:v>1.7638339999999999</c:v>
                  </c:pt>
                  <c:pt idx="6">
                    <c:v>2.166666999999999</c:v>
                  </c:pt>
                  <c:pt idx="7">
                    <c:v>3.9405299999999999</c:v>
                  </c:pt>
                  <c:pt idx="8">
                    <c:v>5.7951129999999909</c:v>
                  </c:pt>
                  <c:pt idx="9">
                    <c:v>7.1550299999999956</c:v>
                  </c:pt>
                  <c:pt idx="10">
                    <c:v>9.9680050000000016</c:v>
                  </c:pt>
                  <c:pt idx="11">
                    <c:v>8.0829039999999992</c:v>
                  </c:pt>
                  <c:pt idx="12">
                    <c:v>9.3377970000000001</c:v>
                  </c:pt>
                  <c:pt idx="13">
                    <c:v>9.5175289999999997</c:v>
                  </c:pt>
                  <c:pt idx="14">
                    <c:v>10.29968</c:v>
                  </c:pt>
                  <c:pt idx="15">
                    <c:v>11.655950000000001</c:v>
                  </c:pt>
                  <c:pt idx="16">
                    <c:v>11.59023</c:v>
                  </c:pt>
                  <c:pt idx="17">
                    <c:v>9.0875380000000003</c:v>
                  </c:pt>
                  <c:pt idx="18">
                    <c:v>7.6974019999999657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xVal>
            <c:numRef>
              <c:f>'120413_IncuCyteData_031014. (2)'!$B$10:$B$28</c:f>
              <c:numCache>
                <c:formatCode>General</c:formatCode>
                <c:ptCount val="1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</c:numCache>
            </c:numRef>
          </c:xVal>
          <c:yVal>
            <c:numRef>
              <c:f>'120413_IncuCyteData_031014. (2)'!$G$10:$G$28</c:f>
              <c:numCache>
                <c:formatCode>General</c:formatCode>
                <c:ptCount val="19"/>
                <c:pt idx="0">
                  <c:v>2.5</c:v>
                </c:pt>
                <c:pt idx="1">
                  <c:v>3.8333330000000001</c:v>
                </c:pt>
                <c:pt idx="2">
                  <c:v>7.5</c:v>
                </c:pt>
                <c:pt idx="3">
                  <c:v>11.33333</c:v>
                </c:pt>
                <c:pt idx="4">
                  <c:v>15.16667</c:v>
                </c:pt>
                <c:pt idx="5">
                  <c:v>20.33333</c:v>
                </c:pt>
                <c:pt idx="6">
                  <c:v>26.66667</c:v>
                </c:pt>
                <c:pt idx="7">
                  <c:v>37.166670000000003</c:v>
                </c:pt>
                <c:pt idx="8">
                  <c:v>47.5</c:v>
                </c:pt>
                <c:pt idx="9">
                  <c:v>59.833329999999997</c:v>
                </c:pt>
                <c:pt idx="10">
                  <c:v>69.666659999999993</c:v>
                </c:pt>
                <c:pt idx="11">
                  <c:v>78.5</c:v>
                </c:pt>
                <c:pt idx="12">
                  <c:v>80.833339999999978</c:v>
                </c:pt>
                <c:pt idx="13">
                  <c:v>90</c:v>
                </c:pt>
                <c:pt idx="14">
                  <c:v>96.5</c:v>
                </c:pt>
                <c:pt idx="15">
                  <c:v>100.83329999999999</c:v>
                </c:pt>
                <c:pt idx="16">
                  <c:v>103</c:v>
                </c:pt>
                <c:pt idx="17">
                  <c:v>101</c:v>
                </c:pt>
                <c:pt idx="18">
                  <c:v>101.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0095872"/>
        <c:axId val="380109952"/>
      </c:scatterChart>
      <c:valAx>
        <c:axId val="380095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380109952"/>
        <c:crosses val="autoZero"/>
        <c:crossBetween val="midCat"/>
      </c:valAx>
      <c:valAx>
        <c:axId val="380109952"/>
        <c:scaling>
          <c:orientation val="minMax"/>
          <c:max val="14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>
                <a:latin typeface="Arial"/>
                <a:cs typeface="Arial"/>
              </a:defRPr>
            </a:pPr>
            <a:endParaRPr lang="en-US"/>
          </a:p>
        </c:txPr>
        <c:crossAx val="38009587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6.7806032059238505E-2"/>
          <c:y val="3.9200052434796798E-3"/>
          <c:w val="0.519446654572844"/>
          <c:h val="0.33490313607622102"/>
        </c:manualLayout>
      </c:layout>
      <c:overlay val="0"/>
      <c:txPr>
        <a:bodyPr/>
        <a:lstStyle/>
        <a:p>
          <a:pPr>
            <a:defRPr sz="10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C97A7A-7A2E-344B-BE84-79CA7B781979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F51979-CDBD-F54A-B215-11E850204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0143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F51979-CDBD-F54A-B215-11E85020430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5672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913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732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055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907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458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544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715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428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161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356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109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459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"/><Relationship Id="rId13" Type="http://schemas.openxmlformats.org/officeDocument/2006/relationships/image" Target="../media/image10.tif"/><Relationship Id="rId18" Type="http://schemas.openxmlformats.org/officeDocument/2006/relationships/image" Target="../media/image15.tif"/><Relationship Id="rId3" Type="http://schemas.openxmlformats.org/officeDocument/2006/relationships/chart" Target="../charts/chart1.xml"/><Relationship Id="rId21" Type="http://schemas.openxmlformats.org/officeDocument/2006/relationships/image" Target="../media/image18.tif"/><Relationship Id="rId7" Type="http://schemas.openxmlformats.org/officeDocument/2006/relationships/image" Target="../media/image4.jpg"/><Relationship Id="rId12" Type="http://schemas.openxmlformats.org/officeDocument/2006/relationships/image" Target="../media/image9.tif"/><Relationship Id="rId17" Type="http://schemas.openxmlformats.org/officeDocument/2006/relationships/image" Target="../media/image14.ti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tif"/><Relationship Id="rId20" Type="http://schemas.openxmlformats.org/officeDocument/2006/relationships/image" Target="../media/image17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g"/><Relationship Id="rId11" Type="http://schemas.openxmlformats.org/officeDocument/2006/relationships/image" Target="../media/image8.tif"/><Relationship Id="rId5" Type="http://schemas.openxmlformats.org/officeDocument/2006/relationships/image" Target="../media/image2.jpg"/><Relationship Id="rId15" Type="http://schemas.openxmlformats.org/officeDocument/2006/relationships/image" Target="../media/image12.tif"/><Relationship Id="rId23" Type="http://schemas.openxmlformats.org/officeDocument/2006/relationships/image" Target="../media/image20.tif"/><Relationship Id="rId10" Type="http://schemas.openxmlformats.org/officeDocument/2006/relationships/image" Target="../media/image7.tif"/><Relationship Id="rId19" Type="http://schemas.openxmlformats.org/officeDocument/2006/relationships/image" Target="../media/image16.tif"/><Relationship Id="rId4" Type="http://schemas.openxmlformats.org/officeDocument/2006/relationships/image" Target="../media/image1.jpg"/><Relationship Id="rId9" Type="http://schemas.openxmlformats.org/officeDocument/2006/relationships/image" Target="../media/image6.tif"/><Relationship Id="rId14" Type="http://schemas.openxmlformats.org/officeDocument/2006/relationships/image" Target="../media/image11.tif"/><Relationship Id="rId22" Type="http://schemas.openxmlformats.org/officeDocument/2006/relationships/image" Target="../media/image19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54748" y="704941"/>
            <a:ext cx="3572682" cy="3031386"/>
            <a:chOff x="1527461" y="1047361"/>
            <a:chExt cx="3572682" cy="3031386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72171441"/>
                </p:ext>
              </p:extLst>
            </p:nvPr>
          </p:nvGraphicFramePr>
          <p:xfrm>
            <a:off x="1800938" y="1047361"/>
            <a:ext cx="3299205" cy="27767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3106659" y="3801748"/>
              <a:ext cx="8259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Time (h)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1071099" y="2188795"/>
              <a:ext cx="1189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Apoptotic cells</a:t>
              </a: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181794" y="45372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A</a:t>
            </a:r>
            <a:endParaRPr lang="en-US" b="1" dirty="0">
              <a:latin typeface="Arial"/>
              <a:cs typeface="Arial"/>
            </a:endParaRPr>
          </a:p>
        </p:txBody>
      </p:sp>
      <p:grpSp>
        <p:nvGrpSpPr>
          <p:cNvPr id="39" name="Group 38"/>
          <p:cNvGrpSpPr/>
          <p:nvPr/>
        </p:nvGrpSpPr>
        <p:grpSpPr>
          <a:xfrm>
            <a:off x="4231326" y="654713"/>
            <a:ext cx="2290098" cy="1952926"/>
            <a:chOff x="4126664" y="1052745"/>
            <a:chExt cx="2290098" cy="1952926"/>
          </a:xfrm>
        </p:grpSpPr>
        <p:sp>
          <p:nvSpPr>
            <p:cNvPr id="10" name="TextBox 9"/>
            <p:cNvSpPr txBox="1"/>
            <p:nvPr/>
          </p:nvSpPr>
          <p:spPr>
            <a:xfrm>
              <a:off x="4249488" y="1533678"/>
              <a:ext cx="898731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Cl. PARP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380861" y="1855018"/>
              <a:ext cx="767358" cy="5449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p-PAK1</a:t>
              </a:r>
            </a:p>
            <a:p>
              <a:pPr algn="r"/>
              <a:r>
                <a:rPr lang="en-US" sz="1200" dirty="0" smtClean="0">
                  <a:latin typeface="Arial"/>
                  <a:cs typeface="Arial"/>
                </a:rPr>
                <a:t>S144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529750" y="2300380"/>
              <a:ext cx="618469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PAK1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349122" y="2678731"/>
              <a:ext cx="799098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GAPDH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126664" y="1079991"/>
              <a:ext cx="1021555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FRAX1036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610116" y="1251747"/>
              <a:ext cx="538104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DTX</a:t>
              </a:r>
              <a:endParaRPr lang="en-US" sz="1200" dirty="0">
                <a:latin typeface="Arial"/>
                <a:cs typeface="Arial"/>
              </a:endParaRPr>
            </a:p>
          </p:txBody>
        </p:sp>
        <p:pic>
          <p:nvPicPr>
            <p:cNvPr id="19" name="Picture 18" descr="cparp.jpg"/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18" r="7075"/>
            <a:stretch/>
          </p:blipFill>
          <p:spPr>
            <a:xfrm>
              <a:off x="5112725" y="1535259"/>
              <a:ext cx="1304033" cy="3237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0" name="Picture 19" descr="gapdh.jpg"/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18" r="7075"/>
            <a:stretch/>
          </p:blipFill>
          <p:spPr>
            <a:xfrm>
              <a:off x="5112725" y="2680311"/>
              <a:ext cx="1304036" cy="3237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" name="Picture 20" descr="pak.jpg"/>
            <p:cNvPicPr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18" r="7075"/>
            <a:stretch/>
          </p:blipFill>
          <p:spPr>
            <a:xfrm>
              <a:off x="5112725" y="2301961"/>
              <a:ext cx="1304037" cy="3237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" name="Picture 22" descr="ppak s144.jpg"/>
            <p:cNvPicPr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18" r="7075" b="44576"/>
            <a:stretch/>
          </p:blipFill>
          <p:spPr>
            <a:xfrm>
              <a:off x="5112725" y="1921214"/>
              <a:ext cx="1304036" cy="3237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6" name="TextBox 25"/>
            <p:cNvSpPr txBox="1"/>
            <p:nvPr/>
          </p:nvSpPr>
          <p:spPr>
            <a:xfrm>
              <a:off x="5213176" y="1226324"/>
              <a:ext cx="257842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-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515455" y="1226324"/>
              <a:ext cx="257842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-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783024" y="1052745"/>
              <a:ext cx="257842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-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213176" y="1052745"/>
              <a:ext cx="257842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-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775166" y="1226324"/>
              <a:ext cx="299882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+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047724" y="1226324"/>
              <a:ext cx="299882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+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507994" y="1052745"/>
              <a:ext cx="299882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048121" y="1052745"/>
              <a:ext cx="299882" cy="326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+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sp>
        <p:nvSpPr>
          <p:cNvPr id="37" name="TextBox 36"/>
          <p:cNvSpPr txBox="1"/>
          <p:nvPr/>
        </p:nvSpPr>
        <p:spPr>
          <a:xfrm>
            <a:off x="3869864" y="446600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B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38" name="Title 1"/>
          <p:cNvSpPr>
            <a:spLocks noGrp="1"/>
          </p:cNvSpPr>
          <p:nvPr>
            <p:ph type="title"/>
          </p:nvPr>
        </p:nvSpPr>
        <p:spPr>
          <a:xfrm>
            <a:off x="52174" y="103934"/>
            <a:ext cx="2352291" cy="319401"/>
          </a:xfrm>
        </p:spPr>
        <p:txBody>
          <a:bodyPr>
            <a:normAutofit fontScale="90000"/>
          </a:bodyPr>
          <a:lstStyle/>
          <a:p>
            <a:pPr algn="l"/>
            <a:r>
              <a:rPr lang="en-US" sz="2000" b="1" dirty="0" err="1" smtClean="0">
                <a:latin typeface="Arial" charset="0"/>
                <a:cs typeface="Arial" charset="0"/>
              </a:rPr>
              <a:t>Suppl</a:t>
            </a:r>
            <a:r>
              <a:rPr lang="en-US" sz="2000" b="1" dirty="0" smtClean="0">
                <a:latin typeface="Arial" charset="0"/>
                <a:cs typeface="Arial" charset="0"/>
              </a:rPr>
              <a:t> Figure 5</a:t>
            </a:r>
            <a:endParaRPr lang="en-US" sz="2000" dirty="0">
              <a:latin typeface="Arial" charset="0"/>
            </a:endParaRPr>
          </a:p>
        </p:txBody>
      </p:sp>
      <p:grpSp>
        <p:nvGrpSpPr>
          <p:cNvPr id="40" name="Group 39"/>
          <p:cNvGrpSpPr>
            <a:grpSpLocks noChangeAspect="1"/>
          </p:cNvGrpSpPr>
          <p:nvPr/>
        </p:nvGrpSpPr>
        <p:grpSpPr>
          <a:xfrm>
            <a:off x="421753" y="3868253"/>
            <a:ext cx="5873670" cy="5202130"/>
            <a:chOff x="551531" y="820529"/>
            <a:chExt cx="6631950" cy="5873714"/>
          </a:xfrm>
        </p:grpSpPr>
        <p:pic>
          <p:nvPicPr>
            <p:cNvPr id="41" name="Picture 40" descr="dmsot288.tif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00581" y="1093231"/>
              <a:ext cx="1371600" cy="1371600"/>
            </a:xfrm>
            <a:prstGeom prst="rect">
              <a:avLst/>
            </a:prstGeom>
          </p:spPr>
        </p:pic>
        <p:pic>
          <p:nvPicPr>
            <p:cNvPr id="42" name="Picture 41" descr="dmsot434.tif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1881" y="1093231"/>
              <a:ext cx="1371600" cy="1371600"/>
            </a:xfrm>
            <a:prstGeom prst="rect">
              <a:avLst/>
            </a:prstGeom>
          </p:spPr>
        </p:pic>
        <p:pic>
          <p:nvPicPr>
            <p:cNvPr id="43" name="Picture 42" descr="fraxt001.tif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74124" y="2502746"/>
              <a:ext cx="1371600" cy="1371600"/>
            </a:xfrm>
            <a:prstGeom prst="rect">
              <a:avLst/>
            </a:prstGeom>
          </p:spPr>
        </p:pic>
        <p:pic>
          <p:nvPicPr>
            <p:cNvPr id="44" name="Picture 43" descr="fraxt434.tif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1881" y="2502746"/>
              <a:ext cx="1371600" cy="1371600"/>
            </a:xfrm>
            <a:prstGeom prst="rect">
              <a:avLst/>
            </a:prstGeom>
          </p:spPr>
        </p:pic>
        <p:pic>
          <p:nvPicPr>
            <p:cNvPr id="45" name="Picture 44" descr="dtxt001.tif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74124" y="3912694"/>
              <a:ext cx="1371600" cy="1371600"/>
            </a:xfrm>
            <a:prstGeom prst="rect">
              <a:avLst/>
            </a:prstGeom>
          </p:spPr>
        </p:pic>
        <p:pic>
          <p:nvPicPr>
            <p:cNvPr id="46" name="Picture 45" descr="combot001.tif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74124" y="5322643"/>
              <a:ext cx="1371600" cy="1371600"/>
            </a:xfrm>
            <a:prstGeom prst="rect">
              <a:avLst/>
            </a:prstGeom>
          </p:spPr>
        </p:pic>
        <p:sp>
          <p:nvSpPr>
            <p:cNvPr id="47" name="TextBox 46"/>
            <p:cNvSpPr txBox="1"/>
            <p:nvPr/>
          </p:nvSpPr>
          <p:spPr>
            <a:xfrm>
              <a:off x="2031801" y="820529"/>
              <a:ext cx="450049" cy="3127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0 h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382578" y="820529"/>
              <a:ext cx="546683" cy="3127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24 h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800167" y="820529"/>
              <a:ext cx="546683" cy="3127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48 h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6211465" y="820529"/>
              <a:ext cx="546683" cy="3127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72 </a:t>
              </a:r>
              <a:r>
                <a:rPr lang="en-US" sz="1200" dirty="0">
                  <a:latin typeface="Arial"/>
                  <a:cs typeface="Arial"/>
                </a:rPr>
                <a:t>h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884560" y="1625145"/>
              <a:ext cx="729771" cy="3127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DMSO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555886" y="3034659"/>
              <a:ext cx="1058446" cy="3127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FRAX1036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058318" y="4444605"/>
              <a:ext cx="556016" cy="3127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DTX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51531" y="5746833"/>
              <a:ext cx="1062801" cy="5212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FRAX1036</a:t>
              </a:r>
            </a:p>
            <a:p>
              <a:pPr algn="r"/>
              <a:r>
                <a:rPr lang="en-US" sz="1200" dirty="0" smtClean="0">
                  <a:latin typeface="Arial"/>
                  <a:cs typeface="Arial"/>
                </a:rPr>
                <a:t>DTX</a:t>
              </a:r>
              <a:endParaRPr lang="en-US" sz="1200" dirty="0">
                <a:latin typeface="Arial"/>
                <a:cs typeface="Arial"/>
              </a:endParaRPr>
            </a:p>
          </p:txBody>
        </p:sp>
        <p:pic>
          <p:nvPicPr>
            <p:cNvPr id="55" name="Picture 54" descr="dmsot144.tif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82993" y="1093231"/>
              <a:ext cx="1371600" cy="1371600"/>
            </a:xfrm>
            <a:prstGeom prst="rect">
              <a:avLst/>
            </a:prstGeom>
          </p:spPr>
        </p:pic>
        <p:sp>
          <p:nvSpPr>
            <p:cNvPr id="56" name="TextBox 55"/>
            <p:cNvSpPr txBox="1"/>
            <p:nvPr/>
          </p:nvSpPr>
          <p:spPr>
            <a:xfrm>
              <a:off x="2999927" y="1110388"/>
              <a:ext cx="287394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bg1"/>
                  </a:solidFill>
                  <a:latin typeface="Arial"/>
                  <a:cs typeface="Arial"/>
                </a:rPr>
                <a:t>*</a:t>
              </a:r>
              <a:endParaRPr lang="en-US" sz="14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pic>
          <p:nvPicPr>
            <p:cNvPr id="57" name="Picture 56" descr="dtxt144.tif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82993" y="3912694"/>
              <a:ext cx="1371600" cy="1371600"/>
            </a:xfrm>
            <a:prstGeom prst="rect">
              <a:avLst/>
            </a:prstGeom>
          </p:spPr>
        </p:pic>
        <p:sp>
          <p:nvSpPr>
            <p:cNvPr id="58" name="TextBox 57"/>
            <p:cNvSpPr txBox="1"/>
            <p:nvPr/>
          </p:nvSpPr>
          <p:spPr>
            <a:xfrm>
              <a:off x="3390806" y="4197708"/>
              <a:ext cx="287394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bg1"/>
                  </a:solidFill>
                  <a:latin typeface="Arial"/>
                  <a:cs typeface="Arial"/>
                </a:rPr>
                <a:t>*</a:t>
              </a:r>
              <a:endParaRPr lang="en-US" sz="14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3872304" y="4496214"/>
              <a:ext cx="287394" cy="3475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latin typeface="Arial"/>
                  <a:cs typeface="Arial"/>
                </a:rPr>
                <a:t>*</a:t>
              </a:r>
            </a:p>
          </p:txBody>
        </p:sp>
        <p:pic>
          <p:nvPicPr>
            <p:cNvPr id="60" name="Picture 59" descr="dtxt434.tif"/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1881" y="3912694"/>
              <a:ext cx="1371600" cy="1371600"/>
            </a:xfrm>
            <a:prstGeom prst="rect">
              <a:avLst/>
            </a:prstGeom>
          </p:spPr>
        </p:pic>
        <p:sp>
          <p:nvSpPr>
            <p:cNvPr id="61" name="TextBox 60"/>
            <p:cNvSpPr txBox="1"/>
            <p:nvPr/>
          </p:nvSpPr>
          <p:spPr>
            <a:xfrm>
              <a:off x="6223801" y="4577573"/>
              <a:ext cx="326887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bg1"/>
                  </a:solidFill>
                  <a:latin typeface="Arial"/>
                  <a:cs typeface="Arial"/>
                </a:rPr>
                <a:t>+</a:t>
              </a:r>
              <a:endParaRPr lang="en-US" sz="14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pic>
          <p:nvPicPr>
            <p:cNvPr id="62" name="Picture 61" descr="fraxt144.tif"/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82993" y="2502746"/>
              <a:ext cx="1371600" cy="1371600"/>
            </a:xfrm>
            <a:prstGeom prst="rect">
              <a:avLst/>
            </a:prstGeom>
          </p:spPr>
        </p:pic>
        <p:sp>
          <p:nvSpPr>
            <p:cNvPr id="63" name="TextBox 62"/>
            <p:cNvSpPr txBox="1"/>
            <p:nvPr/>
          </p:nvSpPr>
          <p:spPr>
            <a:xfrm>
              <a:off x="3196988" y="3511946"/>
              <a:ext cx="303627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FFFF"/>
                  </a:solidFill>
                  <a:latin typeface="Arial"/>
                  <a:cs typeface="Arial"/>
                </a:rPr>
                <a:t>^</a:t>
              </a:r>
              <a:endParaRPr lang="en-US" sz="1400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pic>
          <p:nvPicPr>
            <p:cNvPr id="64" name="Picture 63" descr="combot144.tif"/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82993" y="5322643"/>
              <a:ext cx="1371600" cy="1371600"/>
            </a:xfrm>
            <a:prstGeom prst="rect">
              <a:avLst/>
            </a:prstGeom>
          </p:spPr>
        </p:pic>
        <p:sp>
          <p:nvSpPr>
            <p:cNvPr id="65" name="TextBox 64"/>
            <p:cNvSpPr txBox="1"/>
            <p:nvPr/>
          </p:nvSpPr>
          <p:spPr>
            <a:xfrm>
              <a:off x="3937256" y="5980396"/>
              <a:ext cx="287394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bg1"/>
                  </a:solidFill>
                  <a:latin typeface="Arial"/>
                  <a:cs typeface="Arial"/>
                </a:rPr>
                <a:t>*</a:t>
              </a:r>
              <a:endParaRPr lang="en-US" sz="14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001938" y="5607200"/>
              <a:ext cx="287394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bg1"/>
                  </a:solidFill>
                  <a:latin typeface="Arial"/>
                  <a:cs typeface="Arial"/>
                </a:rPr>
                <a:t>*</a:t>
              </a:r>
              <a:endParaRPr lang="en-US" sz="14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3437040" y="5487939"/>
              <a:ext cx="303627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FFFF"/>
                  </a:solidFill>
                  <a:latin typeface="Arial"/>
                  <a:cs typeface="Arial"/>
                </a:rPr>
                <a:t>^</a:t>
              </a:r>
              <a:endParaRPr lang="en-US" sz="1400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3627814" y="5876111"/>
              <a:ext cx="303627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FFFF"/>
                  </a:solidFill>
                  <a:latin typeface="Arial"/>
                  <a:cs typeface="Arial"/>
                </a:rPr>
                <a:t>^</a:t>
              </a:r>
              <a:endParaRPr lang="en-US" sz="1400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pic>
          <p:nvPicPr>
            <p:cNvPr id="69" name="Picture 68" descr="combot288.tif"/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00581" y="5322643"/>
              <a:ext cx="1371600" cy="1371600"/>
            </a:xfrm>
            <a:prstGeom prst="rect">
              <a:avLst/>
            </a:prstGeom>
          </p:spPr>
        </p:pic>
        <p:sp>
          <p:nvSpPr>
            <p:cNvPr id="70" name="TextBox 69"/>
            <p:cNvSpPr txBox="1"/>
            <p:nvPr/>
          </p:nvSpPr>
          <p:spPr>
            <a:xfrm>
              <a:off x="4608419" y="6292701"/>
              <a:ext cx="303627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FFFF"/>
                  </a:solidFill>
                  <a:latin typeface="Arial"/>
                  <a:cs typeface="Arial"/>
                </a:rPr>
                <a:t>^</a:t>
              </a:r>
              <a:endParaRPr lang="en-US" sz="1400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pic>
          <p:nvPicPr>
            <p:cNvPr id="71" name="Picture 70" descr="dtxt288.tif"/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00581" y="3912694"/>
              <a:ext cx="1371600" cy="1371600"/>
            </a:xfrm>
            <a:prstGeom prst="rect">
              <a:avLst/>
            </a:prstGeom>
          </p:spPr>
        </p:pic>
        <p:sp>
          <p:nvSpPr>
            <p:cNvPr id="72" name="TextBox 71"/>
            <p:cNvSpPr txBox="1"/>
            <p:nvPr/>
          </p:nvSpPr>
          <p:spPr>
            <a:xfrm>
              <a:off x="4946136" y="3966405"/>
              <a:ext cx="326887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bg1"/>
                  </a:solidFill>
                  <a:latin typeface="Arial"/>
                  <a:cs typeface="Arial"/>
                </a:rPr>
                <a:t>+</a:t>
              </a:r>
              <a:endParaRPr lang="en-US" sz="14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4515689" y="4322055"/>
              <a:ext cx="326887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bg1"/>
                  </a:solidFill>
                  <a:latin typeface="Arial"/>
                  <a:cs typeface="Arial"/>
                </a:rPr>
                <a:t>+</a:t>
              </a:r>
              <a:endParaRPr lang="en-US" sz="14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546478" y="4646231"/>
              <a:ext cx="303627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FFFF"/>
                  </a:solidFill>
                  <a:latin typeface="Arial"/>
                  <a:cs typeface="Arial"/>
                </a:rPr>
                <a:t>^</a:t>
              </a:r>
              <a:endParaRPr lang="en-US" sz="1400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pic>
          <p:nvPicPr>
            <p:cNvPr id="75" name="Picture 74" descr="fraxt288.tif"/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00581" y="2502746"/>
              <a:ext cx="1371600" cy="1371600"/>
            </a:xfrm>
            <a:prstGeom prst="rect">
              <a:avLst/>
            </a:prstGeom>
          </p:spPr>
        </p:pic>
        <p:sp>
          <p:nvSpPr>
            <p:cNvPr id="76" name="TextBox 75"/>
            <p:cNvSpPr txBox="1"/>
            <p:nvPr/>
          </p:nvSpPr>
          <p:spPr>
            <a:xfrm>
              <a:off x="4691548" y="3278623"/>
              <a:ext cx="303627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FFFF"/>
                  </a:solidFill>
                  <a:latin typeface="Arial"/>
                  <a:cs typeface="Arial"/>
                </a:rPr>
                <a:t>^</a:t>
              </a:r>
              <a:endParaRPr lang="en-US" sz="1400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pic>
          <p:nvPicPr>
            <p:cNvPr id="77" name="Picture 76" descr="combot434.tif"/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1881" y="5322643"/>
              <a:ext cx="1371600" cy="1371600"/>
            </a:xfrm>
            <a:prstGeom prst="rect">
              <a:avLst/>
            </a:prstGeom>
          </p:spPr>
        </p:pic>
        <p:sp>
          <p:nvSpPr>
            <p:cNvPr id="78" name="TextBox 77"/>
            <p:cNvSpPr txBox="1"/>
            <p:nvPr/>
          </p:nvSpPr>
          <p:spPr>
            <a:xfrm>
              <a:off x="6011894" y="5923369"/>
              <a:ext cx="303627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FFFF"/>
                  </a:solidFill>
                  <a:latin typeface="Arial"/>
                  <a:cs typeface="Arial"/>
                </a:rPr>
                <a:t>^</a:t>
              </a:r>
              <a:endParaRPr lang="en-US" sz="1400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5822073" y="4608568"/>
              <a:ext cx="326887" cy="347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bg1"/>
                  </a:solidFill>
                  <a:latin typeface="Arial"/>
                  <a:cs typeface="Arial"/>
                </a:rPr>
                <a:t>+</a:t>
              </a:r>
              <a:endParaRPr lang="en-US" sz="14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grpSp>
          <p:nvGrpSpPr>
            <p:cNvPr id="80" name="Group 79"/>
            <p:cNvGrpSpPr/>
            <p:nvPr/>
          </p:nvGrpSpPr>
          <p:grpSpPr>
            <a:xfrm>
              <a:off x="1574124" y="1093231"/>
              <a:ext cx="1371600" cy="1371600"/>
              <a:chOff x="1574124" y="930671"/>
              <a:chExt cx="1371600" cy="1371600"/>
            </a:xfrm>
          </p:grpSpPr>
          <p:pic>
            <p:nvPicPr>
              <p:cNvPr id="81" name="Picture 80" descr="dmsot001.tif"/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74124" y="930671"/>
                <a:ext cx="1371600" cy="1371600"/>
              </a:xfrm>
              <a:prstGeom prst="rect">
                <a:avLst/>
              </a:prstGeom>
            </p:spPr>
          </p:pic>
          <p:cxnSp>
            <p:nvCxnSpPr>
              <p:cNvPr id="82" name="Straight Connector 81"/>
              <p:cNvCxnSpPr/>
              <p:nvPr/>
            </p:nvCxnSpPr>
            <p:spPr>
              <a:xfrm>
                <a:off x="2701925" y="2206625"/>
                <a:ext cx="196850" cy="0"/>
              </a:xfrm>
              <a:prstGeom prst="line">
                <a:avLst/>
              </a:prstGeom>
              <a:ln>
                <a:solidFill>
                  <a:srgbClr val="FFFFF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83" name="TextBox 82"/>
          <p:cNvSpPr txBox="1"/>
          <p:nvPr/>
        </p:nvSpPr>
        <p:spPr>
          <a:xfrm>
            <a:off x="181794" y="371722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C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5199078" y="5583629"/>
            <a:ext cx="268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FFFFFF"/>
                </a:solidFill>
                <a:latin typeface="Arial"/>
                <a:cs typeface="Arial"/>
              </a:rPr>
              <a:t>^</a:t>
            </a:r>
            <a:endParaRPr lang="en-US" sz="14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502495" y="5583629"/>
            <a:ext cx="268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FFFFFF"/>
                </a:solidFill>
                <a:latin typeface="Arial"/>
                <a:cs typeface="Arial"/>
              </a:rPr>
              <a:t>^</a:t>
            </a:r>
            <a:endParaRPr lang="en-US" sz="14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6011072" y="7503504"/>
            <a:ext cx="268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FFFFFF"/>
                </a:solidFill>
                <a:latin typeface="Arial"/>
                <a:cs typeface="Arial"/>
              </a:rPr>
              <a:t>^</a:t>
            </a:r>
            <a:endParaRPr lang="en-US" sz="14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87" name="TextBox 86"/>
          <p:cNvSpPr txBox="1"/>
          <p:nvPr/>
        </p:nvSpPr>
        <p:spPr>
          <a:xfrm rot="5400000">
            <a:off x="3333262" y="1049852"/>
            <a:ext cx="2395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solidFill>
                  <a:schemeClr val="accent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100" b="1" dirty="0">
              <a:solidFill>
                <a:schemeClr val="accent3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 rot="5400000">
            <a:off x="3333261" y="935056"/>
            <a:ext cx="2395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100" b="1" dirty="0">
              <a:solidFill>
                <a:schemeClr val="accent4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52863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07</TotalTime>
  <Words>64</Words>
  <Application>Microsoft Office PowerPoint</Application>
  <PresentationFormat>On-screen Show (4:3)</PresentationFormat>
  <Paragraphs>5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uppl Figure 5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nstall</dc:creator>
  <cp:lastModifiedBy>Joachim Rudolph</cp:lastModifiedBy>
  <cp:revision>169</cp:revision>
  <cp:lastPrinted>2015-01-13T20:11:25Z</cp:lastPrinted>
  <dcterms:created xsi:type="dcterms:W3CDTF">2014-04-13T22:32:15Z</dcterms:created>
  <dcterms:modified xsi:type="dcterms:W3CDTF">2015-01-19T07:40:58Z</dcterms:modified>
</cp:coreProperties>
</file>